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9" r:id="rId4"/>
    <p:sldId id="258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69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57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A66BAE-97F2-4DC9-BA12-34556386B92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6BB969A-1C08-4747-A16D-A14D7489860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98A087-6C27-4380-912B-25C67E7693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91AFB7-7207-41C5-A73E-063BF42CB770}" type="datetimeFigureOut">
              <a:rPr lang="en-GB" smtClean="0"/>
              <a:t>25/02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5162A7-0A44-4800-8EEC-2A62E8BFBB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8144C8-9119-445A-9DC7-061B72A1B9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686C5-2198-4E08-873F-D8A9DA38F9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3103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1A12F7-DE74-4216-9546-09C09A06A3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F034412-EEFD-464D-88E9-E5CC33356E1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2B9DAE-DEC4-4B68-8112-BE93F0680E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91AFB7-7207-41C5-A73E-063BF42CB770}" type="datetimeFigureOut">
              <a:rPr lang="en-GB" smtClean="0"/>
              <a:t>25/02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893C16-4E92-4F49-9979-ED7CFBAFDB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CA14A0-B0DC-4550-BDC8-352183B756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686C5-2198-4E08-873F-D8A9DA38F9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5357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5F173D3-2441-4466-AC82-D7DE92C3B80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76ADF29-F1D7-48B8-8DFA-059994EBB0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BCCD12-CDCC-46D1-BC25-DB1AB8F1B7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91AFB7-7207-41C5-A73E-063BF42CB770}" type="datetimeFigureOut">
              <a:rPr lang="en-GB" smtClean="0"/>
              <a:t>25/02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92680B-EA6D-4706-ACD7-45FE5FC3DF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B1C913-4A57-4CEC-972A-CF18069088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686C5-2198-4E08-873F-D8A9DA38F9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67471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05D615-28CC-49F5-9CAC-6A9E6E9B64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EAC40B-877F-4E55-B778-EA1FBCB0AC6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9FB34A-6347-4982-B9BE-D88D43E37C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91AFB7-7207-41C5-A73E-063BF42CB770}" type="datetimeFigureOut">
              <a:rPr lang="en-GB" smtClean="0"/>
              <a:t>25/02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04BD2F-3C6A-4D18-98CD-01A0B3DB18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6855ED-595C-45DF-85A3-5E3265569E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686C5-2198-4E08-873F-D8A9DA38F9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86476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0CC3B8-8701-4747-8617-5C7A3348A6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8FF6563-5A0F-4497-91BF-18D486F89B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CD074D-2F51-49DF-8194-0845AB6BDC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91AFB7-7207-41C5-A73E-063BF42CB770}" type="datetimeFigureOut">
              <a:rPr lang="en-GB" smtClean="0"/>
              <a:t>25/02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30A9DE-11ED-4452-A54F-0107B5FB1B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EB7358-E4BC-4C00-A0F0-A82C123862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686C5-2198-4E08-873F-D8A9DA38F9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15260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6F52B8-57CE-454E-8FB4-AFC40EDC29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08EA040-4BFB-4D20-B244-38D549AF040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A606675-7359-4925-993C-26D1A9AD7C2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BC5A46E-4E46-44E7-ADE1-5B2C36D268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91AFB7-7207-41C5-A73E-063BF42CB770}" type="datetimeFigureOut">
              <a:rPr lang="en-GB" smtClean="0"/>
              <a:t>25/02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797F8CD-FCD2-4337-9EF9-0133E8A4DA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CAD059B-E9B6-4436-B6C2-ABA2F2EDC3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686C5-2198-4E08-873F-D8A9DA38F9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47201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9DFE6E-3932-41AE-8778-60D30B4C8B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0DD8152-F11D-40F1-8D32-AC3D7DBF0F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5219682-E731-4E1E-81A5-57D5383CBAA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DC45D25-4B94-4724-B56D-090919CAD74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0038280-5EB7-40C1-ABA8-DCA54D246DB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4D60476-1C5E-4D95-90FE-5D9969E458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91AFB7-7207-41C5-A73E-063BF42CB770}" type="datetimeFigureOut">
              <a:rPr lang="en-GB" smtClean="0"/>
              <a:t>25/02/2020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668200C-2AFC-4CD9-A556-7321A30CE1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FA6966D-2CFE-4F04-A85C-8B813841C0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686C5-2198-4E08-873F-D8A9DA38F9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974253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8BA27C-9B1F-4A20-8A82-51D2E4D232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D67D53F-C0BF-4F1B-8B98-B5ED8C3151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91AFB7-7207-41C5-A73E-063BF42CB770}" type="datetimeFigureOut">
              <a:rPr lang="en-GB" smtClean="0"/>
              <a:t>25/02/2020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AD0217D-4E79-45DF-8FFB-494838F7D2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BDCB3C2-917A-4AB1-93F6-16CAB80290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686C5-2198-4E08-873F-D8A9DA38F9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10675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493FB66-9CCD-4CF6-A40E-E8FBCB9A76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91AFB7-7207-41C5-A73E-063BF42CB770}" type="datetimeFigureOut">
              <a:rPr lang="en-GB" smtClean="0"/>
              <a:t>25/02/2020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A7B2D07-C726-47B4-990B-1CBDE08D95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A863DFB-0110-4FD2-A77B-109BBE3239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686C5-2198-4E08-873F-D8A9DA38F9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99476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CC1A4C-549B-4337-81A1-383B069320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5898FD0-EBF2-476C-80C8-E9D071D129C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D2B78F0-3BA8-43FD-A579-ECAB7EDA9D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471EAB4-507A-4522-92AD-815EC71992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91AFB7-7207-41C5-A73E-063BF42CB770}" type="datetimeFigureOut">
              <a:rPr lang="en-GB" smtClean="0"/>
              <a:t>25/02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80A313F-525A-4920-9381-8E643DEDC3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743D5A-00A2-4D48-BE1B-BB1F6C52F3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686C5-2198-4E08-873F-D8A9DA38F9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32212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D50696-A5A4-4F04-B905-C4D0EFE8B7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80BA322-28B4-4B61-965C-387AB5095A5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C0BD0F3-5399-442F-AF61-4758174DCD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A19EF60-ECD9-4DEC-9911-46E6A806F0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91AFB7-7207-41C5-A73E-063BF42CB770}" type="datetimeFigureOut">
              <a:rPr lang="en-GB" smtClean="0"/>
              <a:t>25/02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749F45A-A491-4E23-9484-CB455AC641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5DBD622-189D-40C9-A69D-BC1190FBC0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E686C5-2198-4E08-873F-D8A9DA38F9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26981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CDA9E6B-AA08-40D0-8915-B346FBE130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5CB6F0C-E508-4650-B7A3-E3418B86DB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4ACD9E-13AE-4972-9493-583181C5F5E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91AFB7-7207-41C5-A73E-063BF42CB770}" type="datetimeFigureOut">
              <a:rPr lang="en-GB" smtClean="0"/>
              <a:t>25/02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F2C482-D3F1-4B7E-9359-16D06CE1B8F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9D66A6-F075-4515-ADCA-4ADCFF95F37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E686C5-2198-4E08-873F-D8A9DA38F9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04400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plot of chunk unnamed-chunk-59">
            <a:extLst>
              <a:ext uri="{FF2B5EF4-FFF2-40B4-BE49-F238E27FC236}">
                <a16:creationId xmlns:a16="http://schemas.microsoft.com/office/drawing/2014/main" id="{EF271552-4846-4449-AD86-6A32423C3F7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1983" y="1087243"/>
            <a:ext cx="4800600" cy="41148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 descr="plot of chunk unnamed-chunk-67">
            <a:extLst>
              <a:ext uri="{FF2B5EF4-FFF2-40B4-BE49-F238E27FC236}">
                <a16:creationId xmlns:a16="http://schemas.microsoft.com/office/drawing/2014/main" id="{E64F32E1-BBFB-40CF-A804-5A241DCBD23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80618" y="1087243"/>
            <a:ext cx="6173128" cy="4115419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7788C38-C48E-45F0-8765-3050FC7747B8}"/>
              </a:ext>
            </a:extLst>
          </p:cNvPr>
          <p:cNvSpPr txBox="1"/>
          <p:nvPr/>
        </p:nvSpPr>
        <p:spPr>
          <a:xfrm>
            <a:off x="1027611" y="5493758"/>
            <a:ext cx="36670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1A: QQ Plot of EWAS Regular Partner Smoking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F03B8BA-0BE5-4CAA-A050-CC74078F9AB4}"/>
              </a:ext>
            </a:extLst>
          </p:cNvPr>
          <p:cNvSpPr txBox="1"/>
          <p:nvPr/>
        </p:nvSpPr>
        <p:spPr>
          <a:xfrm>
            <a:off x="7058721" y="5493757"/>
            <a:ext cx="41056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1B: Manhattan Plot of EWAS Regular Partner Smoking</a:t>
            </a:r>
          </a:p>
        </p:txBody>
      </p:sp>
    </p:spTree>
    <p:extLst>
      <p:ext uri="{BB962C8B-B14F-4D97-AF65-F5344CB8AC3E}">
        <p14:creationId xmlns:p14="http://schemas.microsoft.com/office/powerpoint/2010/main" val="35449665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plot of chunk unnamed-chunk-56">
            <a:extLst>
              <a:ext uri="{FF2B5EF4-FFF2-40B4-BE49-F238E27FC236}">
                <a16:creationId xmlns:a16="http://schemas.microsoft.com/office/drawing/2014/main" id="{965205A1-B28A-4AD1-995B-31F236B142C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2164" y="981308"/>
            <a:ext cx="4800600" cy="41148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4" descr="plot of chunk unnamed-chunk-64">
            <a:extLst>
              <a:ext uri="{FF2B5EF4-FFF2-40B4-BE49-F238E27FC236}">
                <a16:creationId xmlns:a16="http://schemas.microsoft.com/office/drawing/2014/main" id="{1705487D-EAEF-46F4-8BF2-B4F374CEA2F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89342" y="981308"/>
            <a:ext cx="6172200" cy="41148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1B46AF6-CB95-4744-A19A-D7019EF89516}"/>
              </a:ext>
            </a:extLst>
          </p:cNvPr>
          <p:cNvSpPr txBox="1"/>
          <p:nvPr/>
        </p:nvSpPr>
        <p:spPr>
          <a:xfrm>
            <a:off x="311301" y="5482606"/>
            <a:ext cx="53823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A: QQ Plot of EWAS Regular Partner Smoking (restricted to non-smokers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F01528C-7D10-4277-998F-797753CF1D4A}"/>
              </a:ext>
            </a:extLst>
          </p:cNvPr>
          <p:cNvSpPr txBox="1"/>
          <p:nvPr/>
        </p:nvSpPr>
        <p:spPr>
          <a:xfrm>
            <a:off x="6082061" y="5482606"/>
            <a:ext cx="57986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B: Manhattan Plot of EWAS Regular Partner Smoking (restricted to non-smokers)</a:t>
            </a:r>
          </a:p>
        </p:txBody>
      </p:sp>
    </p:spTree>
    <p:extLst>
      <p:ext uri="{BB962C8B-B14F-4D97-AF65-F5344CB8AC3E}">
        <p14:creationId xmlns:p14="http://schemas.microsoft.com/office/powerpoint/2010/main" val="41662039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DA1D998-9888-4D30-A785-CE2011D7B35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612784" y="1098395"/>
            <a:ext cx="6209608" cy="41148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AABE9D7-30E4-4C90-B1FE-6F0DE79555F7}"/>
              </a:ext>
            </a:extLst>
          </p:cNvPr>
          <p:cNvSpPr txBox="1"/>
          <p:nvPr/>
        </p:nvSpPr>
        <p:spPr>
          <a:xfrm>
            <a:off x="5724071" y="5482606"/>
            <a:ext cx="59870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3B: Manhattan Plot of EWAS Regular Partner Smoking (restricted to regular smokers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FE24CE9-EB63-45DD-AEED-B40565EFAA02}"/>
              </a:ext>
            </a:extLst>
          </p:cNvPr>
          <p:cNvSpPr txBox="1"/>
          <p:nvPr/>
        </p:nvSpPr>
        <p:spPr>
          <a:xfrm>
            <a:off x="240681" y="5482606"/>
            <a:ext cx="49529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3A: QQ Plot of EWAS Regular Partner Smoking (restricted to regular smokers)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16A59E51-81FA-4A73-96A8-336447F84EB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0680" y="1098395"/>
            <a:ext cx="4953000" cy="411480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728937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plot of chunk unnamed-chunk-59">
            <a:extLst>
              <a:ext uri="{FF2B5EF4-FFF2-40B4-BE49-F238E27FC236}">
                <a16:creationId xmlns:a16="http://schemas.microsoft.com/office/drawing/2014/main" id="{244AD32C-E7CB-4FEE-9EEB-BD420D94EC9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7016" y="1098395"/>
            <a:ext cx="4800600" cy="41148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4" descr="plot of chunk unnamed-chunk-67">
            <a:extLst>
              <a:ext uri="{FF2B5EF4-FFF2-40B4-BE49-F238E27FC236}">
                <a16:creationId xmlns:a16="http://schemas.microsoft.com/office/drawing/2014/main" id="{09C675B3-A337-48A5-8887-80803108663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12784" y="1098396"/>
            <a:ext cx="6172200" cy="41148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496A8983-5281-46C6-9148-72CE4137B58B}"/>
              </a:ext>
            </a:extLst>
          </p:cNvPr>
          <p:cNvSpPr txBox="1"/>
          <p:nvPr/>
        </p:nvSpPr>
        <p:spPr>
          <a:xfrm>
            <a:off x="1248931" y="5426615"/>
            <a:ext cx="31167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4A: QQ Plot of EWAS Own Smoking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98116F9-AE6B-4886-A76F-FC11B015E9C5}"/>
              </a:ext>
            </a:extLst>
          </p:cNvPr>
          <p:cNvSpPr txBox="1"/>
          <p:nvPr/>
        </p:nvSpPr>
        <p:spPr>
          <a:xfrm>
            <a:off x="6933739" y="5426615"/>
            <a:ext cx="35302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4B: Manhattan Plot of EWAS Own Smoking</a:t>
            </a:r>
          </a:p>
        </p:txBody>
      </p:sp>
    </p:spTree>
    <p:extLst>
      <p:ext uri="{BB962C8B-B14F-4D97-AF65-F5344CB8AC3E}">
        <p14:creationId xmlns:p14="http://schemas.microsoft.com/office/powerpoint/2010/main" val="41234842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100</Words>
  <Application>Microsoft Office PowerPoint</Application>
  <PresentationFormat>Widescreen</PresentationFormat>
  <Paragraphs>8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ige Hulls</dc:creator>
  <cp:lastModifiedBy>Paige Hulls</cp:lastModifiedBy>
  <cp:revision>7</cp:revision>
  <dcterms:created xsi:type="dcterms:W3CDTF">2019-10-16T17:15:30Z</dcterms:created>
  <dcterms:modified xsi:type="dcterms:W3CDTF">2020-02-25T15:44:22Z</dcterms:modified>
</cp:coreProperties>
</file>